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797675" cy="9929813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-468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EE82E-CA85-4E8C-AEAF-88F661E37879}" type="datetimeFigureOut">
              <a:rPr lang="es-ES" smtClean="0"/>
              <a:pPr/>
              <a:t>25/08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2231D-BF4B-4D50-B56D-0F95DD6F4915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EE82E-CA85-4E8C-AEAF-88F661E37879}" type="datetimeFigureOut">
              <a:rPr lang="es-ES" smtClean="0"/>
              <a:pPr/>
              <a:t>25/08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2231D-BF4B-4D50-B56D-0F95DD6F4915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EE82E-CA85-4E8C-AEAF-88F661E37879}" type="datetimeFigureOut">
              <a:rPr lang="es-ES" smtClean="0"/>
              <a:pPr/>
              <a:t>25/08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2231D-BF4B-4D50-B56D-0F95DD6F4915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EE82E-CA85-4E8C-AEAF-88F661E37879}" type="datetimeFigureOut">
              <a:rPr lang="es-ES" smtClean="0"/>
              <a:pPr/>
              <a:t>25/08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2231D-BF4B-4D50-B56D-0F95DD6F4915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EE82E-CA85-4E8C-AEAF-88F661E37879}" type="datetimeFigureOut">
              <a:rPr lang="es-ES" smtClean="0"/>
              <a:pPr/>
              <a:t>25/08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2231D-BF4B-4D50-B56D-0F95DD6F4915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EE82E-CA85-4E8C-AEAF-88F661E37879}" type="datetimeFigureOut">
              <a:rPr lang="es-ES" smtClean="0"/>
              <a:pPr/>
              <a:t>25/08/2015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2231D-BF4B-4D50-B56D-0F95DD6F4915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EE82E-CA85-4E8C-AEAF-88F661E37879}" type="datetimeFigureOut">
              <a:rPr lang="es-ES" smtClean="0"/>
              <a:pPr/>
              <a:t>25/08/2015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2231D-BF4B-4D50-B56D-0F95DD6F4915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EE82E-CA85-4E8C-AEAF-88F661E37879}" type="datetimeFigureOut">
              <a:rPr lang="es-ES" smtClean="0"/>
              <a:pPr/>
              <a:t>25/08/2015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2231D-BF4B-4D50-B56D-0F95DD6F4915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EE82E-CA85-4E8C-AEAF-88F661E37879}" type="datetimeFigureOut">
              <a:rPr lang="es-ES" smtClean="0"/>
              <a:pPr/>
              <a:t>25/08/2015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2231D-BF4B-4D50-B56D-0F95DD6F4915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EE82E-CA85-4E8C-AEAF-88F661E37879}" type="datetimeFigureOut">
              <a:rPr lang="es-ES" smtClean="0"/>
              <a:pPr/>
              <a:t>25/08/2015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2231D-BF4B-4D50-B56D-0F95DD6F4915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2EE82E-CA85-4E8C-AEAF-88F661E37879}" type="datetimeFigureOut">
              <a:rPr lang="es-ES" smtClean="0"/>
              <a:pPr/>
              <a:t>25/08/2015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2231D-BF4B-4D50-B56D-0F95DD6F4915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2EE82E-CA85-4E8C-AEAF-88F661E37879}" type="datetimeFigureOut">
              <a:rPr lang="es-ES" smtClean="0"/>
              <a:pPr/>
              <a:t>25/08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A2231D-BF4B-4D50-B56D-0F95DD6F4915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4 Tabla"/>
          <p:cNvGraphicFramePr>
            <a:graphicFrameLocks noGrp="1"/>
          </p:cNvGraphicFramePr>
          <p:nvPr/>
        </p:nvGraphicFramePr>
        <p:xfrm>
          <a:off x="179512" y="143108"/>
          <a:ext cx="8784975" cy="6709228"/>
        </p:xfrm>
        <a:graphic>
          <a:graphicData uri="http://schemas.openxmlformats.org/drawingml/2006/table">
            <a:tbl>
              <a:tblPr/>
              <a:tblGrid>
                <a:gridCol w="795399"/>
                <a:gridCol w="653064"/>
                <a:gridCol w="619575"/>
                <a:gridCol w="560966"/>
                <a:gridCol w="569337"/>
                <a:gridCol w="602828"/>
                <a:gridCol w="694928"/>
                <a:gridCol w="646785"/>
                <a:gridCol w="694928"/>
                <a:gridCol w="602828"/>
                <a:gridCol w="720046"/>
                <a:gridCol w="904212"/>
                <a:gridCol w="720079"/>
              </a:tblGrid>
              <a:tr h="31795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ID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trez ID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tart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d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Gene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og 2(LC+/LC-)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Adjusted p-value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og 2 (ADC+/ LC-)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r>
                        <a:rPr lang="es-ES" sz="7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Adjusted</a:t>
                      </a:r>
                      <a:r>
                        <a:rPr lang="es-ES" sz="7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p-</a:t>
                      </a:r>
                      <a:r>
                        <a:rPr lang="es-ES" sz="7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value</a:t>
                      </a:r>
                      <a:endParaRPr lang="es-ES" sz="7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log2 (SCC/LC-)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r>
                        <a:rPr lang="es-ES" sz="7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Adjusted</a:t>
                      </a:r>
                      <a:r>
                        <a:rPr lang="es-ES" sz="7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p-</a:t>
                      </a:r>
                      <a:r>
                        <a:rPr lang="es-ES" sz="7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value</a:t>
                      </a:r>
                      <a:endParaRPr lang="es-ES" sz="7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log2 </a:t>
                      </a:r>
                      <a:r>
                        <a:rPr lang="es-ES" sz="700" b="1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(COPD+/COPD-LC-</a:t>
                      </a:r>
                      <a:r>
                        <a:rPr lang="es-ES" sz="7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)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r>
                        <a:rPr lang="es-ES" sz="7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Adjusted</a:t>
                      </a:r>
                      <a:r>
                        <a:rPr lang="es-ES" sz="7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p-</a:t>
                      </a:r>
                      <a:r>
                        <a:rPr lang="es-ES" sz="7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value</a:t>
                      </a:r>
                      <a:endParaRPr lang="es-ES" sz="7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18555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878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0119054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19254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DLK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382931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0104347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0.03243912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2730309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5504881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7067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1861611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1454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538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24424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0124624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MEG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0.17335273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15608E-0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0310731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476204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5152518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.23264E-0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3299204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6791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29503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29703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4951879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.4151E-0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3884204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.94141E-0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4999120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29757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2339666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6438844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1157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822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1722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1922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770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42415304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51232E-1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40189262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.26914E-0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43283426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.03224E-0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1154446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798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74450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3389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3589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49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9371233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.81898E-1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3896970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53559E-0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4986715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9923E-0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4023002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19915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4290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39330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4132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33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4023908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.41923E-0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9638680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4561814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7967189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23891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807187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7229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012631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39870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4186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66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9500201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16877E-0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4340511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115293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4574660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3316E-0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0588514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800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7403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4584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4784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43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8496971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.32285E-1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1355208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07963E-0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6085797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26766E-0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364059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5141962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756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7403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46720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4871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43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1096995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10219E-1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6099034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41767E-0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6216776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70379E-0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411746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760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0691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4781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4981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12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5935729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32018E-0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2117657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62371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9740213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.40152E-0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2629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7245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7445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49320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5131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43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5237999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10017E-0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216435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76246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8458430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15497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226698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794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0692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4953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5153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13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7065432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.70757E-0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3647873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48346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0640541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.67287E-0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282840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5465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8801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5068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5268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RTL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9507531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.12597E-0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5147279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51523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4123136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.57769E-0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2228563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6937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5776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5976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5935935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.70555E-0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0686702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670492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1310394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26142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0894754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5839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9104;69221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5960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6160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EG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4205290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72434E-0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3930200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14292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4211203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96344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3711681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19900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4291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7597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7797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370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3856426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.16842E-1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8290897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.21408E-0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9969989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17071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5896637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219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56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8966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91660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3-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5357926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85848E-1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3082311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37919E-0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7275344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61688E-0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0551793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5194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9081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9281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9672059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.31824E-1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8304394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16678E-0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40930651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14493E-0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2499255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1238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56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9217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9417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3-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5910230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06116E-0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5630888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99738E-0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5417593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100690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4054991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805844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1700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56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9475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39675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3-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46334628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81624E-0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9717460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87343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51745937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10577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489541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99665694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167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56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0132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0332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3-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46469258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.3473E-1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49084341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87762E-0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43622062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17535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0435158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2574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050724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0223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0423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0.46469258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.3473E-1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49084341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87762E-0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43622062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17535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0435158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7247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56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0302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0502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3-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0.39329316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37034E-10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6080261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43282E-0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42526116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80888E-0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1723605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91171481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5214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0390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0590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0.31113798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2179E-0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701538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10157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4851479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.4095E-0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163095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5706981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021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56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0439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0639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3-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956292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.34803E-0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5310053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17860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3395323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15497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529051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5056306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5191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0540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0740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8805260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74736E-0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4041500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52240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3098671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31996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312278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5861311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063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56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0596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0796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3-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3516327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301925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5417086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5599931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0961972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2539492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1221785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93459594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036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56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0828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1028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3-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3685452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63653E-0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752912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149086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4099631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16602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2097599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1950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56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1048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1248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3-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7580782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80412E-0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6627496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510205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923522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.30616E-0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334932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99868232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19957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57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14670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1666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4-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40155873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.89536E-1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1038577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33694E-0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49903262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8156E-0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2753253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5798869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183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57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1818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2018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4-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0318716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152222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6459898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8058753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3433874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3131476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729385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593196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083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580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1921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21210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4-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4063721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.88509E-0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0592733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004291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7265020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230926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0639187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323251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19979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58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2020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2220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4-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9138216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21425E-0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6225713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6719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240388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.56964E-0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2480667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59155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126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58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2200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2400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4-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7237686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64279E-0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2383269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706543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42179371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126070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93226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99704953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199390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58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2789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29890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4-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8438162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.64877E-0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5312344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97755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1912347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140925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359661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59155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1240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58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3086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3286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4-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025110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31216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660852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2811387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3388662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2417944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2321311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9137216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027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58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3188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3388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4-10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8022247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.11146E-0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3855727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441229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3004402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224438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4318950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5710139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7141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3248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3448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5437111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79127E-0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0862592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105784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41975749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33847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620829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59155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060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58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3294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3494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4-1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6961306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40691E-0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5076509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.33471E-0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40302521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22201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5426704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2270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590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3378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3578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4-1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6435676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6391E-0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1331391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15252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43134049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97906E-0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7395920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124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59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3471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3671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4-1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6109478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02053E-0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0609199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19093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42138937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.15225E-0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0799686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8802486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19959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59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36940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3893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4-1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9061229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02738E-0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8032899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45331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0087004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98897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415327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298897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155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59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3750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3950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4-1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1120676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36835E-0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0205249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38667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2237463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110527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0489898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479553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19991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59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3843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4043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4-1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7540311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36239E-10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2861421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.47483E-0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42503299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64885E-0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2997303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5386238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156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59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3964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4164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4-1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58670495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.38123E-1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5461766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44611E-0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61960541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.19887E-0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8467185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214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59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4066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4266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4-1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2449101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.61886E-1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5865972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38261E-0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891370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.81406E-0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412661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19994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59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4131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4331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4-1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2449101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.61886E-1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5865972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38261E-0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891370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.81406E-0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412661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1710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4482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4682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1287451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970067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9989165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8147106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226644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1453606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0301867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96524486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204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59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4584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47840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4-20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0173360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49467E-0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7004295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160621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2790432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38210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2592823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90296226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7234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59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4681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4881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4-2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072444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06972E-0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6086998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83660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5607098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61201E-0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194717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90247885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229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600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4776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4976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4-2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1239888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45598E-0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5842647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96237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7310606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19349E-0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2216062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5476224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040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60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4871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5071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4-2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832941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.99314E-10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0810406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103401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6558642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79986E-0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0978312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5944319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189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60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4961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5161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4-2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4569448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74915E-0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7523396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523987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2507388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82827E-0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0106580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9100912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061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60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5089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5289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4-25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4758146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01146E-0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0702460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400304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9240549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1069164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1714147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4171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041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76760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0145188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01453882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4-26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83074071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10033E-0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49164267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70574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24570868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43147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0.06888875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4 Tabla"/>
          <p:cNvGraphicFramePr>
            <a:graphicFrameLocks noGrp="1"/>
          </p:cNvGraphicFramePr>
          <p:nvPr/>
        </p:nvGraphicFramePr>
        <p:xfrm>
          <a:off x="251521" y="260648"/>
          <a:ext cx="8712967" cy="6492007"/>
        </p:xfrm>
        <a:graphic>
          <a:graphicData uri="http://schemas.openxmlformats.org/drawingml/2006/table">
            <a:tbl>
              <a:tblPr/>
              <a:tblGrid>
                <a:gridCol w="775841"/>
                <a:gridCol w="637006"/>
                <a:gridCol w="604338"/>
                <a:gridCol w="547172"/>
                <a:gridCol w="555338"/>
                <a:gridCol w="588005"/>
                <a:gridCol w="648182"/>
                <a:gridCol w="660539"/>
                <a:gridCol w="677839"/>
                <a:gridCol w="588005"/>
                <a:gridCol w="702340"/>
                <a:gridCol w="936274"/>
                <a:gridCol w="792088"/>
              </a:tblGrid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ID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trez ID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tart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d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ene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og 2(LC+/LC-)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Adjusted p-value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log 2 (ADC+/ LC-)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r>
                        <a:rPr lang="es-ES" sz="7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Adjusted</a:t>
                      </a:r>
                      <a:r>
                        <a:rPr lang="es-ES" sz="7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p-</a:t>
                      </a:r>
                      <a:r>
                        <a:rPr lang="es-ES" sz="7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value</a:t>
                      </a:r>
                      <a:endParaRPr lang="es-ES" sz="7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log2 (SCC/LC-)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r>
                        <a:rPr lang="es-ES" sz="7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Adjusted</a:t>
                      </a:r>
                      <a:r>
                        <a:rPr lang="es-ES" sz="7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p-</a:t>
                      </a:r>
                      <a:r>
                        <a:rPr lang="es-ES" sz="7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value</a:t>
                      </a:r>
                      <a:endParaRPr lang="es-ES" sz="7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log2 (EPOC+/EPOC-CP-)</a:t>
                      </a: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r>
                        <a:rPr lang="es-ES" sz="7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Adjusted</a:t>
                      </a:r>
                      <a:r>
                        <a:rPr lang="es-ES" sz="7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p-</a:t>
                      </a:r>
                      <a:r>
                        <a:rPr lang="es-ES" sz="7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value</a:t>
                      </a:r>
                      <a:endParaRPr lang="es-ES" sz="7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577" marR="3577" marT="357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ENSG0000020063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76760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0145299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0145499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4-2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9441755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.35641E-0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3909361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0043755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0.35802825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.88895E-0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7320891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048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60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5396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5596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SNORD114-2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0.25872375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50354E-0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0.17810813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0509426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5730804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.26041E-0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2777800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168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61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5492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5692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4-2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252078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.6575E-0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7588485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2620807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9436000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404802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3901910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131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61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5675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5875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4-3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1775971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7117754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653896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49420981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8497354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9520251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0855156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95015274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008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761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5807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6007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NORD114-3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6222274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.91748E-0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7043196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861299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6880612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.48965E-0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2588854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7018732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2209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5909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6109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41639589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.9908E-1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8817537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82099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56142269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35492E-0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4879941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19908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9432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8686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8886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37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3168808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90118E-1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8720495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95086E-0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7677204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6936E-0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1822350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19910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9312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8816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9016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41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9190262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10121E-1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525773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93101E-0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3213315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40973E-0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0647046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774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0702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8861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9061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29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9640609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.69421E-1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5779449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89141E-0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349853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81644E-0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0463901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2174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030225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9040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9240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119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091675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37059E-1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5123843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61138E-0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6842640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01896E-0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27960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19906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4289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9056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9256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323A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1055090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73804E-1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4953698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88496E-0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7268922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1016E-0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8095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1158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821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9085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9285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75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8464333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45179E-1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2680737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63791E-0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4338850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07058E-0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102815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19898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9432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9094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9294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38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9476288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13522E-1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3834895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34215E-0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5206321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68071E-0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73859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776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7440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9162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9362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329-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1330745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.75807E-1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530164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.20504E-0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7441213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14491E-0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0079153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776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7440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9193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9393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329-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3141602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64162E-1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689326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.88769E-0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9455621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30719E-0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012542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19471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7445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9447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9647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49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7774834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65725E-1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2209261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.40605E-0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3735570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54125E-0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0776007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2103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042283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9488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9688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119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7774834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65725E-1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2209261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.40605E-0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3735570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54125E-0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0776007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1204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012633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9682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9882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54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1969194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.62007E-0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657354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192852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7121920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07012E-0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451070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774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7445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49859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0059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49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43771889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.14013E-1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5828990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36017E-0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5199945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23225E-0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1183250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6503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0418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0617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7496261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.39411E-0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434453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4691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0470275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.81928E-0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5366630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7194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4291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0451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0651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376C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3084721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39664E-1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8866295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77984E-0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7192934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.84625E-0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3350396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793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2402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0505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0705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65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4658119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35623E-1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0490620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.41327E-0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8720521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.20535E-0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587632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6488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94325;66461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0560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0760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376A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6737831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.48877E-1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2031800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51226E-0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1378886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19105E-0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604566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1595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012629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0620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0819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30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3865990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65112E-1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8700575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.2722E-0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9371141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.08838E-0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159159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2152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030215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0781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0981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1185-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2411513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86087E-1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617929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29148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9053520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58179E-0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0588762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2161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030220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0903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1103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1185-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5827325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.87418E-1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1717077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.85534E-0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005666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50241E-0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2457310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5886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0999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1199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381HG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097421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17148E-1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6096507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43448E-0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5621106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.98637E-0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2716852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19902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9433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1075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1275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38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8737993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.43382E-1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0412826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56021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6962636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07817E-0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694709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436609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775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6461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1129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1329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487B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0368213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24504E-1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1751057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15842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8941177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63905E-0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032559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59155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256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6461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1215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1415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53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2532925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29749E-1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4786676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98594E-0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40282538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7746E-0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323925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1609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012634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1273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1473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88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4904322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92232E-1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8007021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81507E-0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41869460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30021E-0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0818104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758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6461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1349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1549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544A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6019355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15212E-1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151088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55803E-0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0542848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72159E-0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1122520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764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2402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1438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1638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65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7591801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48893E-0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4657703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339419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096698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.69158E-0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2565765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6525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1684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1883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3417527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.934E-1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0480866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48342E-0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6438614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86826E-0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1521901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755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1955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172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1928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487A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3417527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.934E-1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0480866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48342E-0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6438614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86826E-0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1521901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799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0692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1950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2150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13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4034497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.55184E-1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9295929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64528E-0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8800728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.56659E-0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1990956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774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9433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2022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2222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38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1416494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90249E-1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5782381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.07468E-0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7341942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55013E-0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1560729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802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7443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2023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2223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48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1416494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90249E-1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5782381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.07468E-0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7341942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55013E-0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1560729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800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7441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2105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2305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323B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0325459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05772E-1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4219836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16671E-0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6781213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15202E-0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0670878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797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0694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2459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2659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15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9563043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35275E-1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207797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42218E-0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47844517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.01941E-1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4063345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796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7445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2541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2740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49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1644586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18282E-1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4769493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03704E-0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9045615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.56834E-0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3300868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19901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9432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2684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2884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37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3723733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07483E-0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9191321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30690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7932764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.34643E-0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4172629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1617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012630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2933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3133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54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8931124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62941E-1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2909519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73067E-0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45144839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48088E-0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5828250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19910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7441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3013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3213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40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7115771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59813E-1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1533808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.10557E-0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2901402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48036E-0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3645725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19901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7443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3028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322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41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6029864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93041E-1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0426839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7287E-0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1872172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00941E-0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3678706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19902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4291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3041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3241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36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4578940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73461E-1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8640642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61567E-0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0739691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.17512E-0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3259588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19909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7443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3074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3274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41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342735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.88918E-1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738467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.60101E-0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9657431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.13476E-0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2614689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0795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2402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3156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3356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iR-65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2761938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.71628E-1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6993519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84183E-0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8725909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.96709E-0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1736269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2340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050725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3474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3674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EG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4398386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16755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5043008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 smtClean="0">
                          <a:solidFill>
                            <a:srgbClr val="000000"/>
                          </a:solidFill>
                          <a:latin typeface="Calibri"/>
                        </a:rPr>
                        <a:t>0.06218846</a:t>
                      </a:r>
                      <a:endParaRPr lang="es-ES" sz="700" b="0" i="1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4392720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25751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1909438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3080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4374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54574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15023556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71702E-0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63342113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.23475E-0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45415331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7165788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7023244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5902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87376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87575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INC0052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7122383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.15806E-0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5884765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68249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8645313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31225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1963896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5908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050727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90691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90891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83926274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57584E-0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375317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54947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3024645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12484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201612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13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19740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73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202618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202818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DIO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79327027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.47148E-0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29139862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52482E-1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358658771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06428236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53557735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5202"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NSG0000025849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0302145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2026269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202826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DIO3OS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0049039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86076E-0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197421228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.92423E-10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30232005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32861522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50723405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840014483</a:t>
                      </a:r>
                    </a:p>
                  </a:txBody>
                  <a:tcPr marL="3763" marR="3763" marT="3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2</TotalTime>
  <Words>1870</Words>
  <Application>Microsoft Office PowerPoint</Application>
  <PresentationFormat>Presentación en pantalla (4:3)</PresentationFormat>
  <Paragraphs>1443</Paragraphs>
  <Slides>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3" baseType="lpstr">
      <vt:lpstr>Tema de Office</vt:lpstr>
      <vt:lpstr>Diapositiva 1</vt:lpstr>
      <vt:lpstr>Diapositiva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EQUIPO</dc:creator>
  <cp:lastModifiedBy>EQUIPO</cp:lastModifiedBy>
  <cp:revision>14</cp:revision>
  <dcterms:created xsi:type="dcterms:W3CDTF">2015-03-24T12:42:28Z</dcterms:created>
  <dcterms:modified xsi:type="dcterms:W3CDTF">2015-08-25T10:28:08Z</dcterms:modified>
</cp:coreProperties>
</file>